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0479CA0-CBEA-476E-A09D-6C971C5B83EE}" v="28" dt="2025-05-27T04:48:37.85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46" autoAdjust="0"/>
    <p:restoredTop sz="96301"/>
  </p:normalViewPr>
  <p:slideViewPr>
    <p:cSldViewPr snapToGrid="0" showGuides="1">
      <p:cViewPr>
        <p:scale>
          <a:sx n="80" d="100"/>
          <a:sy n="80" d="100"/>
        </p:scale>
        <p:origin x="144" y="5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omohito Gohda" userId="16111118910_tp_box_2" providerId="OAuth2" clId="{B8790B89-665C-1A40-95AD-C4098349D1A2}"/>
    <pc:docChg chg="modSld">
      <pc:chgData name="Tomohito Gohda" userId="16111118910_tp_box_2" providerId="OAuth2" clId="{B8790B89-665C-1A40-95AD-C4098349D1A2}" dt="2025-02-07T11:46:26.629" v="168" actId="1038"/>
      <pc:docMkLst>
        <pc:docMk/>
      </pc:docMkLst>
      <pc:sldChg chg="addSp delSp modSp mod">
        <pc:chgData name="Tomohito Gohda" userId="16111118910_tp_box_2" providerId="OAuth2" clId="{B8790B89-665C-1A40-95AD-C4098349D1A2}" dt="2025-02-07T11:46:26.629" v="168" actId="1038"/>
        <pc:sldMkLst>
          <pc:docMk/>
          <pc:sldMk cId="4120091339" sldId="257"/>
        </pc:sldMkLst>
      </pc:sldChg>
    </pc:docChg>
  </pc:docChgLst>
  <pc:docChgLst>
    <pc:chgData name="Tomohito Gohda" userId="16111118910_tp_box_2" providerId="OAuth2" clId="{C4F3A07C-74A3-4A89-9EF8-FD2ADDFFFD41}"/>
    <pc:docChg chg="custSel modSld">
      <pc:chgData name="Tomohito Gohda" userId="16111118910_tp_box_2" providerId="OAuth2" clId="{C4F3A07C-74A3-4A89-9EF8-FD2ADDFFFD41}" dt="2025-02-12T08:23:27.577" v="596" actId="1037"/>
      <pc:docMkLst>
        <pc:docMk/>
      </pc:docMkLst>
      <pc:sldChg chg="addSp delSp modSp mod">
        <pc:chgData name="Tomohito Gohda" userId="16111118910_tp_box_2" providerId="OAuth2" clId="{C4F3A07C-74A3-4A89-9EF8-FD2ADDFFFD41}" dt="2025-02-12T08:23:27.577" v="596" actId="1037"/>
        <pc:sldMkLst>
          <pc:docMk/>
          <pc:sldMk cId="4120091339" sldId="257"/>
        </pc:sldMkLst>
      </pc:sldChg>
    </pc:docChg>
  </pc:docChgLst>
  <pc:docChgLst>
    <pc:chgData name="Tomohito Gohda" userId="16111118910_tp_box_2" providerId="OAuth2" clId="{F4588F60-B770-459B-8B97-3B4AF5928E7F}"/>
    <pc:docChg chg="delSld">
      <pc:chgData name="Tomohito Gohda" userId="16111118910_tp_box_2" providerId="OAuth2" clId="{F4588F60-B770-459B-8B97-3B4AF5928E7F}" dt="2025-05-18T14:11:54.520" v="0" actId="47"/>
      <pc:docMkLst>
        <pc:docMk/>
      </pc:docMkLst>
      <pc:sldChg chg="del">
        <pc:chgData name="Tomohito Gohda" userId="16111118910_tp_box_2" providerId="OAuth2" clId="{F4588F60-B770-459B-8B97-3B4AF5928E7F}" dt="2025-05-18T14:11:54.520" v="0" actId="47"/>
        <pc:sldMkLst>
          <pc:docMk/>
          <pc:sldMk cId="889582221" sldId="262"/>
        </pc:sldMkLst>
      </pc:sldChg>
    </pc:docChg>
  </pc:docChgLst>
  <pc:docChgLst>
    <pc:chgData name="Tomohito Gohda" userId="16111118910_tp_box_2" providerId="OAuth2" clId="{58AEAE7F-E706-4A89-81A9-E9C9456D923A}"/>
    <pc:docChg chg="addSld modSld sldOrd">
      <pc:chgData name="Tomohito Gohda" userId="16111118910_tp_box_2" providerId="OAuth2" clId="{58AEAE7F-E706-4A89-81A9-E9C9456D923A}" dt="2025-03-07T07:49:13.342" v="143" actId="20577"/>
      <pc:docMkLst>
        <pc:docMk/>
      </pc:docMkLst>
      <pc:sldChg chg="ord">
        <pc:chgData name="Tomohito Gohda" userId="16111118910_tp_box_2" providerId="OAuth2" clId="{58AEAE7F-E706-4A89-81A9-E9C9456D923A}" dt="2025-03-07T07:36:01.524" v="1"/>
        <pc:sldMkLst>
          <pc:docMk/>
          <pc:sldMk cId="148649888" sldId="258"/>
        </pc:sldMkLst>
      </pc:sldChg>
      <pc:sldChg chg="addSp modSp mod">
        <pc:chgData name="Tomohito Gohda" userId="16111118910_tp_box_2" providerId="OAuth2" clId="{58AEAE7F-E706-4A89-81A9-E9C9456D923A}" dt="2025-03-07T07:43:46.516" v="120" actId="1076"/>
        <pc:sldMkLst>
          <pc:docMk/>
          <pc:sldMk cId="3994653563" sldId="260"/>
        </pc:sldMkLst>
      </pc:sldChg>
      <pc:sldChg chg="addSp modSp new mod">
        <pc:chgData name="Tomohito Gohda" userId="16111118910_tp_box_2" providerId="OAuth2" clId="{58AEAE7F-E706-4A89-81A9-E9C9456D923A}" dt="2025-03-07T07:49:13.342" v="143" actId="20577"/>
        <pc:sldMkLst>
          <pc:docMk/>
          <pc:sldMk cId="188423513" sldId="261"/>
        </pc:sldMkLst>
      </pc:sldChg>
    </pc:docChg>
  </pc:docChgLst>
  <pc:docChgLst>
    <pc:chgData name="Tomohito Gohda" userId="16111118910_tp_box_2" providerId="OAuth2" clId="{729390DA-5486-4B16-975E-E090F4834377}"/>
    <pc:docChg chg="custSel addSld delSld modSld">
      <pc:chgData name="Tomohito Gohda" userId="16111118910_tp_box_2" providerId="OAuth2" clId="{729390DA-5486-4B16-975E-E090F4834377}" dt="2025-02-07T08:27:19.322" v="1593" actId="1035"/>
      <pc:docMkLst>
        <pc:docMk/>
      </pc:docMkLst>
      <pc:sldChg chg="del">
        <pc:chgData name="Tomohito Gohda" userId="16111118910_tp_box_2" providerId="OAuth2" clId="{729390DA-5486-4B16-975E-E090F4834377}" dt="2025-02-07T08:24:37.170" v="1292" actId="47"/>
        <pc:sldMkLst>
          <pc:docMk/>
          <pc:sldMk cId="3559751819" sldId="256"/>
        </pc:sldMkLst>
      </pc:sldChg>
      <pc:sldChg chg="addSp delSp modSp new mod">
        <pc:chgData name="Tomohito Gohda" userId="16111118910_tp_box_2" providerId="OAuth2" clId="{729390DA-5486-4B16-975E-E090F4834377}" dt="2025-02-07T08:27:19.322" v="1593" actId="1035"/>
        <pc:sldMkLst>
          <pc:docMk/>
          <pc:sldMk cId="4120091339" sldId="257"/>
        </pc:sldMkLst>
      </pc:sldChg>
    </pc:docChg>
  </pc:docChgLst>
  <pc:docChgLst>
    <pc:chgData name="Tomohito Gohda" userId="16111118910_tp_box_2" providerId="OAuth2" clId="{EFBA14BF-2F99-4CD7-98B1-937C9B601838}"/>
    <pc:docChg chg="addSld delSld modSld">
      <pc:chgData name="Tomohito Gohda" userId="16111118910_tp_box_2" providerId="OAuth2" clId="{EFBA14BF-2F99-4CD7-98B1-937C9B601838}" dt="2025-04-25T05:52:59.760" v="45" actId="1037"/>
      <pc:docMkLst>
        <pc:docMk/>
      </pc:docMkLst>
      <pc:sldChg chg="modSp del mod">
        <pc:chgData name="Tomohito Gohda" userId="16111118910_tp_box_2" providerId="OAuth2" clId="{EFBA14BF-2F99-4CD7-98B1-937C9B601838}" dt="2025-04-25T05:52:53.595" v="24" actId="47"/>
        <pc:sldMkLst>
          <pc:docMk/>
          <pc:sldMk cId="1605540878" sldId="259"/>
        </pc:sldMkLst>
      </pc:sldChg>
      <pc:sldChg chg="new del">
        <pc:chgData name="Tomohito Gohda" userId="16111118910_tp_box_2" providerId="OAuth2" clId="{EFBA14BF-2F99-4CD7-98B1-937C9B601838}" dt="2025-04-25T05:52:41.167" v="23" actId="47"/>
        <pc:sldMkLst>
          <pc:docMk/>
          <pc:sldMk cId="2436930861" sldId="260"/>
        </pc:sldMkLst>
      </pc:sldChg>
      <pc:sldChg chg="modSp add mod">
        <pc:chgData name="Tomohito Gohda" userId="16111118910_tp_box_2" providerId="OAuth2" clId="{EFBA14BF-2F99-4CD7-98B1-937C9B601838}" dt="2025-04-25T05:52:59.760" v="45" actId="1037"/>
        <pc:sldMkLst>
          <pc:docMk/>
          <pc:sldMk cId="2836190524" sldId="261"/>
        </pc:sldMkLst>
      </pc:sldChg>
    </pc:docChg>
  </pc:docChgLst>
  <pc:docChgLst>
    <pc:chgData name="Tomohito Gohda" userId="16111118910_tp_box_2" providerId="OAuth2" clId="{BB381E87-C985-4A44-8873-B5FDDC81D1EA}"/>
    <pc:docChg chg="modSld">
      <pc:chgData name="Tomohito Gohda" userId="16111118910_tp_box_2" providerId="OAuth2" clId="{BB381E87-C985-4A44-8873-B5FDDC81D1EA}" dt="2025-03-09T10:10:23.178" v="49" actId="20577"/>
      <pc:docMkLst>
        <pc:docMk/>
      </pc:docMkLst>
      <pc:sldChg chg="addSp modSp mod">
        <pc:chgData name="Tomohito Gohda" userId="16111118910_tp_box_2" providerId="OAuth2" clId="{BB381E87-C985-4A44-8873-B5FDDC81D1EA}" dt="2025-03-09T10:10:23.178" v="49" actId="20577"/>
        <pc:sldMkLst>
          <pc:docMk/>
          <pc:sldMk cId="4120091339" sldId="257"/>
        </pc:sldMkLst>
      </pc:sldChg>
    </pc:docChg>
  </pc:docChgLst>
  <pc:docChgLst>
    <pc:chgData name="Tomohito Gohda" userId="16111118910_tp_box_2" providerId="OAuth2" clId="{47C85317-F56B-4275-B59D-FE23BA0363CB}"/>
    <pc:docChg chg="delSld">
      <pc:chgData name="Tomohito Gohda" userId="16111118910_tp_box_2" providerId="OAuth2" clId="{47C85317-F56B-4275-B59D-FE23BA0363CB}" dt="2025-03-05T04:51:34.352" v="0" actId="2696"/>
      <pc:docMkLst>
        <pc:docMk/>
      </pc:docMkLst>
      <pc:sldChg chg="del">
        <pc:chgData name="Tomohito Gohda" userId="16111118910_tp_box_2" providerId="OAuth2" clId="{47C85317-F56B-4275-B59D-FE23BA0363CB}" dt="2025-03-05T04:51:34.352" v="0" actId="2696"/>
        <pc:sldMkLst>
          <pc:docMk/>
          <pc:sldMk cId="1705389277" sldId="259"/>
        </pc:sldMkLst>
      </pc:sldChg>
    </pc:docChg>
  </pc:docChgLst>
  <pc:docChgLst>
    <pc:chgData name="Tomohito Gohda" userId="16111118910_tp_box_2" providerId="OAuth2" clId="{345B01BA-9081-439E-85A1-7C5473D06122}"/>
    <pc:docChg chg="modSld">
      <pc:chgData name="Tomohito Gohda" userId="16111118910_tp_box_2" providerId="OAuth2" clId="{345B01BA-9081-439E-85A1-7C5473D06122}" dt="2025-03-26T04:59:54.146" v="113" actId="20577"/>
      <pc:docMkLst>
        <pc:docMk/>
      </pc:docMkLst>
      <pc:sldChg chg="modSp mod">
        <pc:chgData name="Tomohito Gohda" userId="16111118910_tp_box_2" providerId="OAuth2" clId="{345B01BA-9081-439E-85A1-7C5473D06122}" dt="2025-03-26T04:59:22.103" v="79" actId="1038"/>
        <pc:sldMkLst>
          <pc:docMk/>
          <pc:sldMk cId="4120091339" sldId="257"/>
        </pc:sldMkLst>
      </pc:sldChg>
      <pc:sldChg chg="modSp mod">
        <pc:chgData name="Tomohito Gohda" userId="16111118910_tp_box_2" providerId="OAuth2" clId="{345B01BA-9081-439E-85A1-7C5473D06122}" dt="2025-03-26T04:59:54.146" v="113" actId="20577"/>
        <pc:sldMkLst>
          <pc:docMk/>
          <pc:sldMk cId="1605540878" sldId="259"/>
        </pc:sldMkLst>
      </pc:sldChg>
    </pc:docChg>
  </pc:docChgLst>
  <pc:docChgLst>
    <pc:chgData name="Tomohito Gohda" userId="16111118910_tp_box_2" providerId="OAuth2" clId="{25F6A9B3-AB41-4A51-BBB3-2790C498F43A}"/>
    <pc:docChg chg="custSel delSld modSld">
      <pc:chgData name="Tomohito Gohda" userId="16111118910_tp_box_2" providerId="OAuth2" clId="{25F6A9B3-AB41-4A51-BBB3-2790C498F43A}" dt="2025-03-07T13:32:36.997" v="1613" actId="47"/>
      <pc:docMkLst>
        <pc:docMk/>
      </pc:docMkLst>
      <pc:sldChg chg="addSp delSp modSp mod">
        <pc:chgData name="Tomohito Gohda" userId="16111118910_tp_box_2" providerId="OAuth2" clId="{25F6A9B3-AB41-4A51-BBB3-2790C498F43A}" dt="2025-03-07T13:32:20.040" v="1611" actId="1036"/>
        <pc:sldMkLst>
          <pc:docMk/>
          <pc:sldMk cId="1605540878" sldId="259"/>
        </pc:sldMkLst>
      </pc:sldChg>
      <pc:sldChg chg="addSp delSp modSp del mod">
        <pc:chgData name="Tomohito Gohda" userId="16111118910_tp_box_2" providerId="OAuth2" clId="{25F6A9B3-AB41-4A51-BBB3-2790C498F43A}" dt="2025-03-07T13:32:35.987" v="1612" actId="47"/>
        <pc:sldMkLst>
          <pc:docMk/>
          <pc:sldMk cId="3994653563" sldId="260"/>
        </pc:sldMkLst>
      </pc:sldChg>
      <pc:sldChg chg="del">
        <pc:chgData name="Tomohito Gohda" userId="16111118910_tp_box_2" providerId="OAuth2" clId="{25F6A9B3-AB41-4A51-BBB3-2790C498F43A}" dt="2025-03-07T13:32:36.997" v="1613" actId="47"/>
        <pc:sldMkLst>
          <pc:docMk/>
          <pc:sldMk cId="188423513" sldId="261"/>
        </pc:sldMkLst>
      </pc:sldChg>
    </pc:docChg>
  </pc:docChgLst>
  <pc:docChgLst>
    <pc:chgData name="Tomohito Gohda" userId="16111118910_tp_box_2" providerId="OAuth2" clId="{59BF2A45-4AD0-40B2-99CA-069A99CFF4B5}"/>
    <pc:docChg chg="custSel addSld delSld modSld">
      <pc:chgData name="Tomohito Gohda" userId="16111118910_tp_box_2" providerId="OAuth2" clId="{59BF2A45-4AD0-40B2-99CA-069A99CFF4B5}" dt="2025-05-18T13:13:13.143" v="1538" actId="47"/>
      <pc:docMkLst>
        <pc:docMk/>
      </pc:docMkLst>
      <pc:sldChg chg="del">
        <pc:chgData name="Tomohito Gohda" userId="16111118910_tp_box_2" providerId="OAuth2" clId="{59BF2A45-4AD0-40B2-99CA-069A99CFF4B5}" dt="2025-05-18T13:13:13.143" v="1538" actId="47"/>
        <pc:sldMkLst>
          <pc:docMk/>
          <pc:sldMk cId="2836190524" sldId="261"/>
        </pc:sldMkLst>
      </pc:sldChg>
      <pc:sldChg chg="addSp delSp modSp add mod">
        <pc:chgData name="Tomohito Gohda" userId="16111118910_tp_box_2" providerId="OAuth2" clId="{59BF2A45-4AD0-40B2-99CA-069A99CFF4B5}" dt="2025-05-18T13:12:57.731" v="1537" actId="1035"/>
        <pc:sldMkLst>
          <pc:docMk/>
          <pc:sldMk cId="889582221" sldId="262"/>
        </pc:sldMkLst>
      </pc:sldChg>
    </pc:docChg>
  </pc:docChgLst>
  <pc:docChgLst>
    <pc:chgData name="Tomohito Gohda" userId="16111118910_tp_box_2" providerId="OAuth2" clId="{7DC90407-51D5-B24F-85AE-C935CB679440}"/>
    <pc:docChg chg="modSld">
      <pc:chgData name="Tomohito Gohda" userId="16111118910_tp_box_2" providerId="OAuth2" clId="{7DC90407-51D5-B24F-85AE-C935CB679440}" dt="2025-02-07T08:06:06.838" v="6" actId="1076"/>
      <pc:docMkLst>
        <pc:docMk/>
      </pc:docMkLst>
      <pc:sldChg chg="modSp mod">
        <pc:chgData name="Tomohito Gohda" userId="16111118910_tp_box_2" providerId="OAuth2" clId="{7DC90407-51D5-B24F-85AE-C935CB679440}" dt="2025-02-07T08:06:06.838" v="6" actId="1076"/>
        <pc:sldMkLst>
          <pc:docMk/>
          <pc:sldMk cId="3559751819" sldId="256"/>
        </pc:sldMkLst>
      </pc:sldChg>
    </pc:docChg>
  </pc:docChgLst>
  <pc:docChgLst>
    <pc:chgData name="Tomohito Gohda" userId="16111118910_tp_box_2" providerId="OAuth2" clId="{E9F6E172-EE87-4576-9D22-6CF9058A606D}"/>
    <pc:docChg chg="delSld modSld">
      <pc:chgData name="Tomohito Gohda" userId="16111118910_tp_box_2" providerId="OAuth2" clId="{E9F6E172-EE87-4576-9D22-6CF9058A606D}" dt="2025-04-07T05:25:10.463" v="49" actId="20577"/>
      <pc:docMkLst>
        <pc:docMk/>
      </pc:docMkLst>
      <pc:sldChg chg="modSp mod">
        <pc:chgData name="Tomohito Gohda" userId="16111118910_tp_box_2" providerId="OAuth2" clId="{E9F6E172-EE87-4576-9D22-6CF9058A606D}" dt="2025-04-07T05:23:38.677" v="33" actId="1037"/>
        <pc:sldMkLst>
          <pc:docMk/>
          <pc:sldMk cId="148649888" sldId="258"/>
        </pc:sldMkLst>
        <pc:spChg chg="mod">
          <ac:chgData name="Tomohito Gohda" userId="16111118910_tp_box_2" providerId="OAuth2" clId="{E9F6E172-EE87-4576-9D22-6CF9058A606D}" dt="2025-04-07T05:23:38.677" v="33" actId="1037"/>
          <ac:spMkLst>
            <pc:docMk/>
            <pc:sldMk cId="148649888" sldId="258"/>
            <ac:spMk id="2" creationId="{639BA941-7E04-7017-BC73-3DE13775536C}"/>
          </ac:spMkLst>
        </pc:spChg>
        <pc:grpChg chg="mod">
          <ac:chgData name="Tomohito Gohda" userId="16111118910_tp_box_2" providerId="OAuth2" clId="{E9F6E172-EE87-4576-9D22-6CF9058A606D}" dt="2025-04-07T05:23:26.793" v="2" actId="1037"/>
          <ac:grpSpMkLst>
            <pc:docMk/>
            <pc:sldMk cId="148649888" sldId="258"/>
            <ac:grpSpMk id="3" creationId="{860A8BBD-B316-7E25-4AE6-490508C3B3B3}"/>
          </ac:grpSpMkLst>
        </pc:grpChg>
      </pc:sldChg>
      <pc:sldChg chg="modSp mod">
        <pc:chgData name="Tomohito Gohda" userId="16111118910_tp_box_2" providerId="OAuth2" clId="{E9F6E172-EE87-4576-9D22-6CF9058A606D}" dt="2025-04-07T05:25:10.463" v="49" actId="20577"/>
        <pc:sldMkLst>
          <pc:docMk/>
          <pc:sldMk cId="1605540878" sldId="259"/>
        </pc:sldMkLst>
      </pc:sldChg>
      <pc:sldChg chg="del">
        <pc:chgData name="Tomohito Gohda" userId="16111118910_tp_box_2" providerId="OAuth2" clId="{E9F6E172-EE87-4576-9D22-6CF9058A606D}" dt="2025-04-07T05:23:15.226" v="0" actId="47"/>
        <pc:sldMkLst>
          <pc:docMk/>
          <pc:sldMk cId="2836190524" sldId="261"/>
        </pc:sldMkLst>
      </pc:sldChg>
    </pc:docChg>
  </pc:docChgLst>
  <pc:docChgLst>
    <pc:chgData name="Tomohito Gohda" userId="16111118910_tp_box_2" providerId="OAuth2" clId="{5F04CFA9-973C-8544-80FC-901F85239908}"/>
    <pc:docChg chg="custSel modSld">
      <pc:chgData name="Tomohito Gohda" userId="16111118910_tp_box_2" providerId="OAuth2" clId="{5F04CFA9-973C-8544-80FC-901F85239908}" dt="2025-03-08T11:03:25.693" v="277" actId="1037"/>
      <pc:docMkLst>
        <pc:docMk/>
      </pc:docMkLst>
      <pc:sldChg chg="addSp delSp modSp mod">
        <pc:chgData name="Tomohito Gohda" userId="16111118910_tp_box_2" providerId="OAuth2" clId="{5F04CFA9-973C-8544-80FC-901F85239908}" dt="2025-03-08T11:03:25.693" v="277" actId="1037"/>
        <pc:sldMkLst>
          <pc:docMk/>
          <pc:sldMk cId="1605540878" sldId="259"/>
        </pc:sldMkLst>
      </pc:sldChg>
    </pc:docChg>
  </pc:docChgLst>
  <pc:docChgLst>
    <pc:chgData name="Tomohito Gohda" userId="16111118910_tp_box_2" providerId="OAuth2" clId="{67E5DC67-0CBA-46EE-AC9A-5C5F2F49D908}"/>
    <pc:docChg chg="addSld">
      <pc:chgData name="Tomohito Gohda" userId="16111118910_tp_box_2" providerId="OAuth2" clId="{67E5DC67-0CBA-46EE-AC9A-5C5F2F49D908}" dt="2025-02-16T04:08:57.709" v="0" actId="680"/>
      <pc:docMkLst>
        <pc:docMk/>
      </pc:docMkLst>
      <pc:sldChg chg="new">
        <pc:chgData name="Tomohito Gohda" userId="16111118910_tp_box_2" providerId="OAuth2" clId="{67E5DC67-0CBA-46EE-AC9A-5C5F2F49D908}" dt="2025-02-16T04:08:57.709" v="0" actId="680"/>
        <pc:sldMkLst>
          <pc:docMk/>
          <pc:sldMk cId="148649888" sldId="258"/>
        </pc:sldMkLst>
      </pc:sldChg>
    </pc:docChg>
  </pc:docChgLst>
  <pc:docChgLst>
    <pc:chgData name="Tomohito Gohda" userId="16111118910_tp_box_2" providerId="OAuth2" clId="{B150BD0C-B4B3-4E5A-BED6-2569EF0F7FA5}"/>
    <pc:docChg chg="modSld">
      <pc:chgData name="Tomohito Gohda" userId="16111118910_tp_box_2" providerId="OAuth2" clId="{B150BD0C-B4B3-4E5A-BED6-2569EF0F7FA5}" dt="2025-03-08T01:04:01.960" v="1" actId="1076"/>
      <pc:docMkLst>
        <pc:docMk/>
      </pc:docMkLst>
      <pc:sldChg chg="addSp modSp mod">
        <pc:chgData name="Tomohito Gohda" userId="16111118910_tp_box_2" providerId="OAuth2" clId="{B150BD0C-B4B3-4E5A-BED6-2569EF0F7FA5}" dt="2025-03-08T01:04:01.960" v="1" actId="1076"/>
        <pc:sldMkLst>
          <pc:docMk/>
          <pc:sldMk cId="148649888" sldId="258"/>
        </pc:sldMkLst>
        <pc:spChg chg="mod">
          <ac:chgData name="Tomohito Gohda" userId="16111118910_tp_box_2" providerId="OAuth2" clId="{B150BD0C-B4B3-4E5A-BED6-2569EF0F7FA5}" dt="2025-03-08T01:03:56.405" v="0" actId="164"/>
          <ac:spMkLst>
            <pc:docMk/>
            <pc:sldMk cId="148649888" sldId="258"/>
            <ac:spMk id="4" creationId="{A3F1FA06-F6C3-07FB-50F5-546B3D34F6CA}"/>
          </ac:spMkLst>
        </pc:spChg>
        <pc:spChg chg="mod">
          <ac:chgData name="Tomohito Gohda" userId="16111118910_tp_box_2" providerId="OAuth2" clId="{B150BD0C-B4B3-4E5A-BED6-2569EF0F7FA5}" dt="2025-03-08T01:03:56.405" v="0" actId="164"/>
          <ac:spMkLst>
            <pc:docMk/>
            <pc:sldMk cId="148649888" sldId="258"/>
            <ac:spMk id="6" creationId="{7DB1B83A-15C4-68B1-AFE6-919BE5D65D7E}"/>
          </ac:spMkLst>
        </pc:spChg>
        <pc:spChg chg="mod">
          <ac:chgData name="Tomohito Gohda" userId="16111118910_tp_box_2" providerId="OAuth2" clId="{B150BD0C-B4B3-4E5A-BED6-2569EF0F7FA5}" dt="2025-03-08T01:03:56.405" v="0" actId="164"/>
          <ac:spMkLst>
            <pc:docMk/>
            <pc:sldMk cId="148649888" sldId="258"/>
            <ac:spMk id="7" creationId="{E1A20840-9C37-B69D-3BFF-60353B4FEDD1}"/>
          </ac:spMkLst>
        </pc:spChg>
        <pc:spChg chg="mod">
          <ac:chgData name="Tomohito Gohda" userId="16111118910_tp_box_2" providerId="OAuth2" clId="{B150BD0C-B4B3-4E5A-BED6-2569EF0F7FA5}" dt="2025-03-08T01:03:56.405" v="0" actId="164"/>
          <ac:spMkLst>
            <pc:docMk/>
            <pc:sldMk cId="148649888" sldId="258"/>
            <ac:spMk id="13" creationId="{240A9AA7-7EDE-E01F-0065-B7C3CA98B998}"/>
          </ac:spMkLst>
        </pc:spChg>
        <pc:grpChg chg="add mod">
          <ac:chgData name="Tomohito Gohda" userId="16111118910_tp_box_2" providerId="OAuth2" clId="{B150BD0C-B4B3-4E5A-BED6-2569EF0F7FA5}" dt="2025-03-08T01:04:01.960" v="1" actId="1076"/>
          <ac:grpSpMkLst>
            <pc:docMk/>
            <pc:sldMk cId="148649888" sldId="258"/>
            <ac:grpSpMk id="3" creationId="{860A8BBD-B316-7E25-4AE6-490508C3B3B3}"/>
          </ac:grpSpMkLst>
        </pc:grpChg>
        <pc:cxnChg chg="mod">
          <ac:chgData name="Tomohito Gohda" userId="16111118910_tp_box_2" providerId="OAuth2" clId="{B150BD0C-B4B3-4E5A-BED6-2569EF0F7FA5}" dt="2025-03-08T01:03:56.405" v="0" actId="164"/>
          <ac:cxnSpMkLst>
            <pc:docMk/>
            <pc:sldMk cId="148649888" sldId="258"/>
            <ac:cxnSpMk id="9" creationId="{31BBB259-0B63-A718-61E4-529002A93B54}"/>
          </ac:cxnSpMkLst>
        </pc:cxnChg>
        <pc:cxnChg chg="mod">
          <ac:chgData name="Tomohito Gohda" userId="16111118910_tp_box_2" providerId="OAuth2" clId="{B150BD0C-B4B3-4E5A-BED6-2569EF0F7FA5}" dt="2025-03-08T01:03:56.405" v="0" actId="164"/>
          <ac:cxnSpMkLst>
            <pc:docMk/>
            <pc:sldMk cId="148649888" sldId="258"/>
            <ac:cxnSpMk id="10" creationId="{BBD199C5-5C5C-7C75-C9F9-FB0214B44F17}"/>
          </ac:cxnSpMkLst>
        </pc:cxnChg>
        <pc:cxnChg chg="mod">
          <ac:chgData name="Tomohito Gohda" userId="16111118910_tp_box_2" providerId="OAuth2" clId="{B150BD0C-B4B3-4E5A-BED6-2569EF0F7FA5}" dt="2025-03-08T01:03:56.405" v="0" actId="164"/>
          <ac:cxnSpMkLst>
            <pc:docMk/>
            <pc:sldMk cId="148649888" sldId="258"/>
            <ac:cxnSpMk id="12" creationId="{A8F8427A-9635-3A33-BC8F-C9FDCF778ABD}"/>
          </ac:cxnSpMkLst>
        </pc:cxnChg>
      </pc:sldChg>
    </pc:docChg>
  </pc:docChgLst>
  <pc:docChgLst>
    <pc:chgData name="Tomohito Gohda" userId="16111118910_tp_box_2" providerId="OAuth2" clId="{04743EE1-8662-4F4D-B0CD-3DACEEB1E986}"/>
    <pc:docChg chg="modSld">
      <pc:chgData name="Tomohito Gohda" userId="16111118910_tp_box_2" providerId="OAuth2" clId="{04743EE1-8662-4F4D-B0CD-3DACEEB1E986}" dt="2025-02-16T04:17:45.808" v="66" actId="20577"/>
      <pc:docMkLst>
        <pc:docMk/>
      </pc:docMkLst>
      <pc:sldChg chg="addSp modSp mod">
        <pc:chgData name="Tomohito Gohda" userId="16111118910_tp_box_2" providerId="OAuth2" clId="{04743EE1-8662-4F4D-B0CD-3DACEEB1E986}" dt="2025-02-16T04:17:45.808" v="66" actId="20577"/>
        <pc:sldMkLst>
          <pc:docMk/>
          <pc:sldMk cId="148649888" sldId="258"/>
        </pc:sldMkLst>
      </pc:sldChg>
    </pc:docChg>
  </pc:docChgLst>
  <pc:docChgLst>
    <pc:chgData name="Tomohito Gohda" userId="16111118910_tp_box_2" providerId="OAuth2" clId="{07488DE2-4F52-465D-AADF-EFF3AD9CC021}"/>
    <pc:docChg chg="custSel modSld">
      <pc:chgData name="Tomohito Gohda" userId="16111118910_tp_box_2" providerId="OAuth2" clId="{07488DE2-4F52-465D-AADF-EFF3AD9CC021}" dt="2025-02-20T05:55:31.570" v="189" actId="14100"/>
      <pc:docMkLst>
        <pc:docMk/>
      </pc:docMkLst>
      <pc:sldChg chg="addSp delSp modSp mod">
        <pc:chgData name="Tomohito Gohda" userId="16111118910_tp_box_2" providerId="OAuth2" clId="{07488DE2-4F52-465D-AADF-EFF3AD9CC021}" dt="2025-02-20T05:55:31.570" v="189" actId="14100"/>
        <pc:sldMkLst>
          <pc:docMk/>
          <pc:sldMk cId="148649888" sldId="258"/>
        </pc:sldMkLst>
      </pc:sldChg>
    </pc:docChg>
  </pc:docChgLst>
  <pc:docChgLst>
    <pc:chgData name="Tomohito Gohda" userId="16111118910_tp_box_2" providerId="OAuth2" clId="{50479CA0-CBEA-476E-A09D-6C971C5B83EE}"/>
    <pc:docChg chg="modSld">
      <pc:chgData name="Tomohito Gohda" userId="16111118910_tp_box_2" providerId="OAuth2" clId="{50479CA0-CBEA-476E-A09D-6C971C5B83EE}" dt="2025-05-27T04:48:37.857" v="28" actId="1035"/>
      <pc:docMkLst>
        <pc:docMk/>
      </pc:docMkLst>
      <pc:sldChg chg="modSp mod">
        <pc:chgData name="Tomohito Gohda" userId="16111118910_tp_box_2" providerId="OAuth2" clId="{50479CA0-CBEA-476E-A09D-6C971C5B83EE}" dt="2025-05-27T04:48:37.857" v="28" actId="1035"/>
        <pc:sldMkLst>
          <pc:docMk/>
          <pc:sldMk cId="148649888" sldId="258"/>
        </pc:sldMkLst>
        <pc:spChg chg="mod">
          <ac:chgData name="Tomohito Gohda" userId="16111118910_tp_box_2" providerId="OAuth2" clId="{50479CA0-CBEA-476E-A09D-6C971C5B83EE}" dt="2025-05-27T04:48:37.857" v="28" actId="1035"/>
          <ac:spMkLst>
            <pc:docMk/>
            <pc:sldMk cId="148649888" sldId="258"/>
            <ac:spMk id="2" creationId="{639BA941-7E04-7017-BC73-3DE13775536C}"/>
          </ac:spMkLst>
        </pc:spChg>
      </pc:sldChg>
    </pc:docChg>
  </pc:docChgLst>
  <pc:docChgLst>
    <pc:chgData name="Tomohito Gohda" userId="16111118910_tp_box_2" providerId="OAuth2" clId="{B671A05C-A7ED-4FE9-9CE4-FB954F93E861}"/>
    <pc:docChg chg="addSld modSld">
      <pc:chgData name="Tomohito Gohda" userId="16111118910_tp_box_2" providerId="OAuth2" clId="{B671A05C-A7ED-4FE9-9CE4-FB954F93E861}" dt="2025-03-07T07:18:47.451" v="33" actId="680"/>
      <pc:docMkLst>
        <pc:docMk/>
      </pc:docMkLst>
      <pc:sldChg chg="addSp modSp new mod">
        <pc:chgData name="Tomohito Gohda" userId="16111118910_tp_box_2" providerId="OAuth2" clId="{B671A05C-A7ED-4FE9-9CE4-FB954F93E861}" dt="2025-03-07T07:17:40.737" v="32" actId="20577"/>
        <pc:sldMkLst>
          <pc:docMk/>
          <pc:sldMk cId="1605540878" sldId="259"/>
        </pc:sldMkLst>
      </pc:sldChg>
      <pc:sldChg chg="new">
        <pc:chgData name="Tomohito Gohda" userId="16111118910_tp_box_2" providerId="OAuth2" clId="{B671A05C-A7ED-4FE9-9CE4-FB954F93E861}" dt="2025-03-07T07:18:47.451" v="33" actId="680"/>
        <pc:sldMkLst>
          <pc:docMk/>
          <pc:sldMk cId="3994653563" sldId="260"/>
        </pc:sldMkLst>
      </pc:sldChg>
    </pc:docChg>
  </pc:docChgLst>
  <pc:docChgLst>
    <pc:chgData name="Tomohito Gohda" userId="16111118910_tp_box_2" providerId="OAuth2" clId="{4F4BA662-FAB5-4B00-B9D1-6EEB922BD03A}"/>
    <pc:docChg chg="modSld">
      <pc:chgData name="Tomohito Gohda" userId="16111118910_tp_box_2" providerId="OAuth2" clId="{4F4BA662-FAB5-4B00-B9D1-6EEB922BD03A}" dt="2025-04-08T04:42:42.662" v="0" actId="164"/>
      <pc:docMkLst>
        <pc:docMk/>
      </pc:docMkLst>
      <pc:sldChg chg="addSp modSp">
        <pc:chgData name="Tomohito Gohda" userId="16111118910_tp_box_2" providerId="OAuth2" clId="{4F4BA662-FAB5-4B00-B9D1-6EEB922BD03A}" dt="2025-04-08T04:42:42.662" v="0" actId="164"/>
        <pc:sldMkLst>
          <pc:docMk/>
          <pc:sldMk cId="1605540878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241D9EA-2696-A5DD-3960-4F4E636083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8165242-57A8-7177-A74E-2778007925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A087A92-642F-A6DA-533F-59EAB50F5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04EA20E-4C23-CB27-4D6D-79C07BE12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092E28-C45C-3711-5177-04B6E6F87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545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D5698D-A28C-7756-C365-A612AC3834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582B913-C870-E370-B17F-42CBB1BA86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440009F-060A-6FA3-293D-9E30D930C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F76C9F-996D-4347-ACCD-151751FFA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515FFC-9CB0-B286-8C27-13D3240D3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11181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D0DAC85-C106-C760-9E8F-A16EDB6645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26F4542-0230-9209-73C7-0CC7320B41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0DDD0BA-E008-C38F-8095-8138C52C5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8BC77AD-54F6-4C5B-FE5E-B71B9A3EF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1F606E-7632-3F30-5A1E-0D693E4F4D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1092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18910C-CBD6-D96B-28BC-96B9F2D5D3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6F82F8-EBBD-07F2-86F5-E3E33AC8BD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EE0FD48-44F4-6CA3-28C1-76016C396F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77F74B-0FBA-B8B4-CF26-75C2E66C5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AAD8C78-4793-6B83-DDF1-E822B3DC12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538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FE5231E-AE5C-35BB-2775-04AC6A710E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1FFEFFD-894D-7B95-0C47-865103497A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0001F0-7579-07B8-C6E2-7A3974AD42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375E61-8DA0-2669-A71B-AE63A6300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57919A7-CA35-5B7A-7C16-17BB32E9B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312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7552C6-22DA-1E82-516C-0D303267D3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7704BD9-6F0D-86FA-B9D6-621D30BB7F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F5B5B47-521C-1FD5-6294-358D624235F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0CDB27-F40B-B15C-BEF4-A6E88DD2C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27FAB90-7482-BD28-6840-C5EE9BF43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0B9D44-0BD5-B341-ED50-F3EE56705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490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5A641C-4249-C9D8-0CCC-E8AA4E3F2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EED04E2-B220-6E5A-C146-37529ED121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8893423-FC18-2936-1262-9842D7422A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8F5AB44-95C7-054D-1806-510220F5B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873DEF0-BF53-C2AA-24A0-40595FF70A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4D1F015F-96D3-C73A-612B-CE7650B13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FAA90FB-3E11-9F31-E772-DA572ECADE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5847AAD-F23B-43EE-ED46-4A6C87EB5B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7200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DEC614-8D62-8E56-4F04-2E3505C209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907787A-3294-23AA-0598-AD6C65DD4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D6029E0-98A9-4F6F-3501-3FDD1C8B9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3CB39AC-B77C-7BB6-7F5F-A831A34FA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8910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E883465-475C-FA0A-7EB4-575CC339C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1C3EE46-8550-B0F4-4D05-7484F9A62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F4BD288-5BD3-B5C6-6555-3889206F0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7624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C694DB-2671-3353-7A9E-AC4514238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7E0F9A-90C5-46E2-55CC-43568C95B5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2B50E52-EDC2-75C1-C44A-F1AB8A3404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3126EB2-420B-D2C9-1F74-393E53F36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91B183B-DE8D-5306-2676-E5CBECABFF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D9A93DA-6FCC-7EFA-2CE9-1F02C0CFD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9371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2AA388A-34F0-C03B-DFC1-1B7BDCA1D7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906A157-C77C-A3B7-0B80-EAC066CDB2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045E88D-C32C-3A7B-085E-F3C810FA7E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06DD7C3-E6BC-E67A-2B8C-AAE137CD4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101A0B-731B-34B9-47A6-57C558DFEC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9DD96D3-A0B9-1431-77A2-4E969CE40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9424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40E339-9C97-0996-F770-3970678DAB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87FCB31-332C-BF94-D56B-98D07BE168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0F300A-07B8-23BC-2D4D-F12D0B20B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897D84-8CE4-413D-B75C-C666536AAF94}" type="datetimeFigureOut">
              <a:rPr kumimoji="1" lang="ja-JP" altLang="en-US" smtClean="0"/>
              <a:t>2025/5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65CA350-A9F4-C8FB-B036-E6FA070EBC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C31568-1868-1A88-E1BD-BFB1E2D956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21D5BC-DE81-4E37-BDE0-F8C41E90EC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9223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4">
            <a:extLst>
              <a:ext uri="{FF2B5EF4-FFF2-40B4-BE49-F238E27FC236}">
                <a16:creationId xmlns:a16="http://schemas.microsoft.com/office/drawing/2014/main" id="{639BA941-7E04-7017-BC73-3DE1377553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448" y="13100"/>
            <a:ext cx="4879028" cy="3271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ja-JP"/>
            </a:defPPr>
            <a:lvl1pPr marL="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1pPr>
            <a:lvl2pPr marL="4572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2pPr>
            <a:lvl3pPr marL="9144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3pPr>
            <a:lvl4pPr marL="13716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4pPr>
            <a:lvl5pPr marL="18288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5pPr>
            <a:lvl6pPr marL="22860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6pPr>
            <a:lvl7pPr marL="27432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7pPr>
            <a:lvl8pPr marL="32004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8pPr>
            <a:lvl9pPr marL="3657600" algn="l" defTabSz="914400" rtl="0" eaLnBrk="0" fontAlgn="base" latinLnBrk="0" hangingPunct="0">
              <a:spcBef>
                <a:spcPct val="0"/>
              </a:spcBef>
              <a:spcAft>
                <a:spcPct val="0"/>
              </a:spcAft>
              <a:defRPr kumimoji="1" sz="1800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9pPr>
          </a:lstStyle>
          <a:p>
            <a:pPr algn="ctr"/>
            <a:r>
              <a:rPr lang="en-GB" altLang="ja-JP" sz="1200" b="1" kern="100" dirty="0">
                <a:effectLst/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Supplementary Figure 1: </a:t>
            </a:r>
            <a:r>
              <a:rPr lang="en-US" altLang="ja-JP" sz="1200" dirty="0">
                <a:effectLst/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Screening and selection of study participants</a:t>
            </a:r>
            <a:r>
              <a:rPr lang="en-US" altLang="ja-JP" sz="1200" kern="100" dirty="0">
                <a:effectLst/>
                <a:latin typeface="Segoe UI" panose="020B0502040204020203" pitchFamily="34" charset="0"/>
                <a:ea typeface="游明朝" panose="02020400000000000000" pitchFamily="18" charset="-128"/>
                <a:cs typeface="Segoe UI" panose="020B0502040204020203" pitchFamily="34" charset="0"/>
              </a:rPr>
              <a:t>.</a:t>
            </a:r>
            <a:endParaRPr lang="ja-JP" altLang="ja-JP" sz="1200" kern="100" dirty="0">
              <a:effectLst/>
              <a:latin typeface="Segoe UI" panose="020B0502040204020203" pitchFamily="34" charset="0"/>
              <a:ea typeface="游明朝" panose="02020400000000000000" pitchFamily="18" charset="-128"/>
              <a:cs typeface="Segoe UI" panose="020B0502040204020203" pitchFamily="34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60A8BBD-B316-7E25-4AE6-490508C3B3B3}"/>
              </a:ext>
            </a:extLst>
          </p:cNvPr>
          <p:cNvGrpSpPr/>
          <p:nvPr/>
        </p:nvGrpSpPr>
        <p:grpSpPr>
          <a:xfrm>
            <a:off x="422937" y="633314"/>
            <a:ext cx="6583026" cy="2910841"/>
            <a:chOff x="2500013" y="810271"/>
            <a:chExt cx="6583026" cy="2910841"/>
          </a:xfrm>
        </p:grpSpPr>
        <p:sp>
          <p:nvSpPr>
            <p:cNvPr id="4" name="テキスト ボックス 1">
              <a:extLst>
                <a:ext uri="{FF2B5EF4-FFF2-40B4-BE49-F238E27FC236}">
                  <a16:creationId xmlns:a16="http://schemas.microsoft.com/office/drawing/2014/main" id="{A3F1FA06-F6C3-07FB-50F5-546B3D34F6CA}"/>
                </a:ext>
              </a:extLst>
            </p:cNvPr>
            <p:cNvSpPr txBox="1"/>
            <p:nvPr/>
          </p:nvSpPr>
          <p:spPr>
            <a:xfrm>
              <a:off x="2500013" y="810271"/>
              <a:ext cx="2247218" cy="46166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People with diabetes (n = 738)</a:t>
              </a:r>
            </a:p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July 1, 2014~March 31, 2016)</a:t>
              </a:r>
              <a:endParaRPr lang="ja-JP" altLang="en-US" sz="1200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6" name="テキスト ボックス 3">
              <a:extLst>
                <a:ext uri="{FF2B5EF4-FFF2-40B4-BE49-F238E27FC236}">
                  <a16:creationId xmlns:a16="http://schemas.microsoft.com/office/drawing/2014/main" id="{7DB1B83A-15C4-68B1-AFE6-919BE5D65D7E}"/>
                </a:ext>
              </a:extLst>
            </p:cNvPr>
            <p:cNvSpPr txBox="1"/>
            <p:nvPr/>
          </p:nvSpPr>
          <p:spPr>
            <a:xfrm>
              <a:off x="4379761" y="2215150"/>
              <a:ext cx="4703278" cy="101566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square" rtlCol="0" anchor="ctr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Follow-up &lt;6 months (n = 39)</a:t>
              </a:r>
            </a:p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Type 1 diabetes (n = 74)</a:t>
              </a:r>
            </a:p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Other types of diabetes except type 1 and type 2 diabetes (n = 19) Baseline eGFR &lt;30 </a:t>
              </a:r>
              <a:r>
                <a:rPr lang="en-US" altLang="ja-JP" sz="1200" dirty="0">
                  <a:latin typeface="Segoe UI" panose="020B0502040204020203" pitchFamily="34" charset="0"/>
                  <a:ea typeface="游明朝" panose="02020400000000000000" pitchFamily="18" charset="-128"/>
                  <a:cs typeface="Segoe UI" panose="020B0502040204020203" pitchFamily="34" charset="0"/>
                </a:rPr>
                <a:t>mL/min/1.73</a:t>
              </a:r>
              <a:r>
                <a:rPr lang="ja-JP" altLang="en-US" sz="1200" dirty="0">
                  <a:latin typeface="Segoe UI" panose="020B0502040204020203" pitchFamily="34" charset="0"/>
                  <a:ea typeface="游明朝" panose="02020400000000000000" pitchFamily="18" charset="-128"/>
                  <a:cs typeface="Segoe UI" panose="020B0502040204020203" pitchFamily="34" charset="0"/>
                </a:rPr>
                <a:t> </a:t>
              </a:r>
              <a:r>
                <a:rPr lang="en-US" altLang="ja-JP" sz="1200" dirty="0">
                  <a:latin typeface="Segoe UI" panose="020B0502040204020203" pitchFamily="34" charset="0"/>
                  <a:ea typeface="游明朝" panose="02020400000000000000" pitchFamily="18" charset="-128"/>
                  <a:cs typeface="Segoe UI" panose="020B0502040204020203" pitchFamily="34" charset="0"/>
                </a:rPr>
                <a:t>m</a:t>
              </a:r>
              <a:r>
                <a:rPr lang="en-US" altLang="ja-JP" sz="1200" baseline="30000" dirty="0">
                  <a:latin typeface="Segoe UI" panose="020B0502040204020203" pitchFamily="34" charset="0"/>
                  <a:ea typeface="游明朝" panose="02020400000000000000" pitchFamily="18" charset="-128"/>
                  <a:cs typeface="Segoe UI" panose="020B0502040204020203" pitchFamily="34" charset="0"/>
                </a:rPr>
                <a:t>2 </a:t>
              </a:r>
              <a:r>
                <a:rPr lang="en-US" altLang="ja-JP" sz="1200" dirty="0">
                  <a:latin typeface="Segoe UI" panose="020B0502040204020203" pitchFamily="34" charset="0"/>
                  <a:ea typeface="游明朝" panose="02020400000000000000" pitchFamily="18" charset="-128"/>
                  <a:cs typeface="Segoe UI" panose="020B0502040204020203" pitchFamily="34" charset="0"/>
                </a:rPr>
                <a:t>(n = 31)</a:t>
              </a:r>
              <a:endParaRPr lang="en-US" altLang="ja-JP" sz="1200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Missing data of GA (n = 1)</a:t>
              </a:r>
              <a:endParaRPr lang="ja-JP" altLang="en-US" sz="1200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sp>
          <p:nvSpPr>
            <p:cNvPr id="7" name="テキスト ボックス 7">
              <a:extLst>
                <a:ext uri="{FF2B5EF4-FFF2-40B4-BE49-F238E27FC236}">
                  <a16:creationId xmlns:a16="http://schemas.microsoft.com/office/drawing/2014/main" id="{E1A20840-9C37-B69D-3BFF-60353B4FEDD1}"/>
                </a:ext>
              </a:extLst>
            </p:cNvPr>
            <p:cNvSpPr txBox="1"/>
            <p:nvPr/>
          </p:nvSpPr>
          <p:spPr>
            <a:xfrm>
              <a:off x="2500013" y="3444113"/>
              <a:ext cx="2060372" cy="2769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Study participants (n = 571)</a:t>
              </a:r>
              <a:endParaRPr lang="ja-JP" altLang="en-US" sz="1200" dirty="0">
                <a:latin typeface="Segoe UI" panose="020B0502040204020203" pitchFamily="34" charset="0"/>
                <a:cs typeface="Segoe UI" panose="020B0502040204020203" pitchFamily="34" charset="0"/>
              </a:endParaRPr>
            </a:p>
          </p:txBody>
        </p:sp>
        <p:cxnSp>
          <p:nvCxnSpPr>
            <p:cNvPr id="9" name="直線矢印コネクタ 8">
              <a:extLst>
                <a:ext uri="{FF2B5EF4-FFF2-40B4-BE49-F238E27FC236}">
                  <a16:creationId xmlns:a16="http://schemas.microsoft.com/office/drawing/2014/main" id="{31BBB259-0B63-A718-61E4-529002A93B54}"/>
                </a:ext>
              </a:extLst>
            </p:cNvPr>
            <p:cNvCxnSpPr>
              <a:cxnSpLocks/>
            </p:cNvCxnSpPr>
            <p:nvPr/>
          </p:nvCxnSpPr>
          <p:spPr>
            <a:xfrm>
              <a:off x="2877005" y="1283513"/>
              <a:ext cx="0" cy="214548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矢印コネクタ 9">
              <a:extLst>
                <a:ext uri="{FF2B5EF4-FFF2-40B4-BE49-F238E27FC236}">
                  <a16:creationId xmlns:a16="http://schemas.microsoft.com/office/drawing/2014/main" id="{BBD199C5-5C5C-7C75-C9F9-FB0214B44F17}"/>
                </a:ext>
              </a:extLst>
            </p:cNvPr>
            <p:cNvCxnSpPr>
              <a:cxnSpLocks/>
            </p:cNvCxnSpPr>
            <p:nvPr/>
          </p:nvCxnSpPr>
          <p:spPr>
            <a:xfrm>
              <a:off x="2885482" y="1626557"/>
              <a:ext cx="148848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矢印コネクタ 11">
              <a:extLst>
                <a:ext uri="{FF2B5EF4-FFF2-40B4-BE49-F238E27FC236}">
                  <a16:creationId xmlns:a16="http://schemas.microsoft.com/office/drawing/2014/main" id="{A8F8427A-9635-3A33-BC8F-C9FDCF778ABD}"/>
                </a:ext>
              </a:extLst>
            </p:cNvPr>
            <p:cNvCxnSpPr>
              <a:cxnSpLocks/>
            </p:cNvCxnSpPr>
            <p:nvPr/>
          </p:nvCxnSpPr>
          <p:spPr>
            <a:xfrm>
              <a:off x="2882017" y="2722222"/>
              <a:ext cx="148848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3">
              <a:extLst>
                <a:ext uri="{FF2B5EF4-FFF2-40B4-BE49-F238E27FC236}">
                  <a16:creationId xmlns:a16="http://schemas.microsoft.com/office/drawing/2014/main" id="{240A9AA7-7EDE-E01F-0065-B7C3CA98B998}"/>
                </a:ext>
              </a:extLst>
            </p:cNvPr>
            <p:cNvSpPr txBox="1"/>
            <p:nvPr/>
          </p:nvSpPr>
          <p:spPr>
            <a:xfrm>
              <a:off x="4379761" y="1401240"/>
              <a:ext cx="3301160" cy="461665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txBody>
            <a:bodyPr wrap="none" rtlCol="0" anchor="ctr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Withdrew consent (n = 1)</a:t>
              </a:r>
            </a:p>
            <a:p>
              <a:r>
                <a:rPr lang="en-US" altLang="ja-JP" sz="1200" dirty="0">
                  <a:latin typeface="Segoe UI" panose="020B0502040204020203" pitchFamily="34" charset="0"/>
                  <a:cs typeface="Segoe UI" panose="020B0502040204020203" pitchFamily="34" charset="0"/>
                </a:rPr>
                <a:t>Undergoing renal replacement therapy (n = 2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8649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5</TotalTime>
  <Words>109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egoe U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MOHITO GOHDA</dc:creator>
  <cp:lastModifiedBy>TOMOHITO GOHDA</cp:lastModifiedBy>
  <cp:revision>8</cp:revision>
  <dcterms:created xsi:type="dcterms:W3CDTF">2025-02-07T00:48:26Z</dcterms:created>
  <dcterms:modified xsi:type="dcterms:W3CDTF">2025-05-27T04:48:42Z</dcterms:modified>
</cp:coreProperties>
</file>